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5" autoAdjust="0"/>
    <p:restoredTop sz="94660"/>
  </p:normalViewPr>
  <p:slideViewPr>
    <p:cSldViewPr snapToGrid="0" showGuides="1">
      <p:cViewPr varScale="1">
        <p:scale>
          <a:sx n="95" d="100"/>
          <a:sy n="95" d="100"/>
        </p:scale>
        <p:origin x="90" y="7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19FAE-2E52-4309-88B2-C1AB180951E9}" type="datetimeFigureOut">
              <a:rPr lang="ko-KR" altLang="en-US" smtClean="0"/>
              <a:t>2022-05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D943-4748-4500-9F17-A57F75D0A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7006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19FAE-2E52-4309-88B2-C1AB180951E9}" type="datetimeFigureOut">
              <a:rPr lang="ko-KR" altLang="en-US" smtClean="0"/>
              <a:t>2022-05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D943-4748-4500-9F17-A57F75D0A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0601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19FAE-2E52-4309-88B2-C1AB180951E9}" type="datetimeFigureOut">
              <a:rPr lang="ko-KR" altLang="en-US" smtClean="0"/>
              <a:t>2022-05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D943-4748-4500-9F17-A57F75D0A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9507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19FAE-2E52-4309-88B2-C1AB180951E9}" type="datetimeFigureOut">
              <a:rPr lang="ko-KR" altLang="en-US" smtClean="0"/>
              <a:t>2022-05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D943-4748-4500-9F17-A57F75D0A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6707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19FAE-2E52-4309-88B2-C1AB180951E9}" type="datetimeFigureOut">
              <a:rPr lang="ko-KR" altLang="en-US" smtClean="0"/>
              <a:t>2022-05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D943-4748-4500-9F17-A57F75D0A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3337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19FAE-2E52-4309-88B2-C1AB180951E9}" type="datetimeFigureOut">
              <a:rPr lang="ko-KR" altLang="en-US" smtClean="0"/>
              <a:t>2022-05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D943-4748-4500-9F17-A57F75D0A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3170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19FAE-2E52-4309-88B2-C1AB180951E9}" type="datetimeFigureOut">
              <a:rPr lang="ko-KR" altLang="en-US" smtClean="0"/>
              <a:t>2022-05-2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D943-4748-4500-9F17-A57F75D0A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2131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19FAE-2E52-4309-88B2-C1AB180951E9}" type="datetimeFigureOut">
              <a:rPr lang="ko-KR" altLang="en-US" smtClean="0"/>
              <a:t>2022-05-2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D943-4748-4500-9F17-A57F75D0A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9582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19FAE-2E52-4309-88B2-C1AB180951E9}" type="datetimeFigureOut">
              <a:rPr lang="ko-KR" altLang="en-US" smtClean="0"/>
              <a:t>2022-05-2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D943-4748-4500-9F17-A57F75D0A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208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19FAE-2E52-4309-88B2-C1AB180951E9}" type="datetimeFigureOut">
              <a:rPr lang="ko-KR" altLang="en-US" smtClean="0"/>
              <a:t>2022-05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D943-4748-4500-9F17-A57F75D0A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2658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19FAE-2E52-4309-88B2-C1AB180951E9}" type="datetimeFigureOut">
              <a:rPr lang="ko-KR" altLang="en-US" smtClean="0"/>
              <a:t>2022-05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0D943-4748-4500-9F17-A57F75D0A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1095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C19FAE-2E52-4309-88B2-C1AB180951E9}" type="datetimeFigureOut">
              <a:rPr lang="ko-KR" altLang="en-US" smtClean="0"/>
              <a:t>2022-05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E0D943-4748-4500-9F17-A57F75D0A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41512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066312"/>
              </p:ext>
            </p:extLst>
          </p:nvPr>
        </p:nvGraphicFramePr>
        <p:xfrm>
          <a:off x="440880" y="708617"/>
          <a:ext cx="2109555" cy="454687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2109555">
                  <a:extLst>
                    <a:ext uri="{9D8B030D-6E8A-4147-A177-3AD203B41FA5}">
                      <a16:colId xmlns:a16="http://schemas.microsoft.com/office/drawing/2014/main" val="1242873084"/>
                    </a:ext>
                  </a:extLst>
                </a:gridCol>
              </a:tblGrid>
              <a:tr h="41335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Patient</a:t>
                      </a:r>
                      <a:r>
                        <a:rPr lang="en-US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 01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052216976"/>
                  </a:ext>
                </a:extLst>
              </a:tr>
              <a:tr h="4133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tient</a:t>
                      </a:r>
                      <a:r>
                        <a:rPr lang="en-US" altLang="ko-KR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02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16405404"/>
                  </a:ext>
                </a:extLst>
              </a:tr>
              <a:tr h="4133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tient</a:t>
                      </a:r>
                      <a:r>
                        <a:rPr lang="en-US" altLang="ko-KR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03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643453067"/>
                  </a:ext>
                </a:extLst>
              </a:tr>
              <a:tr h="4133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tient</a:t>
                      </a:r>
                      <a:r>
                        <a:rPr lang="en-US" altLang="ko-KR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04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764416701"/>
                  </a:ext>
                </a:extLst>
              </a:tr>
              <a:tr h="4133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tient</a:t>
                      </a:r>
                      <a:r>
                        <a:rPr lang="en-US" altLang="ko-KR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05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515472177"/>
                  </a:ext>
                </a:extLst>
              </a:tr>
              <a:tr h="4133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tient</a:t>
                      </a:r>
                      <a:r>
                        <a:rPr lang="en-US" altLang="ko-KR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06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124092920"/>
                  </a:ext>
                </a:extLst>
              </a:tr>
              <a:tr h="4133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tient</a:t>
                      </a:r>
                      <a:r>
                        <a:rPr lang="en-US" altLang="ko-KR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07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906603925"/>
                  </a:ext>
                </a:extLst>
              </a:tr>
              <a:tr h="4133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tient</a:t>
                      </a:r>
                      <a:r>
                        <a:rPr lang="en-US" altLang="ko-KR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08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690424445"/>
                  </a:ext>
                </a:extLst>
              </a:tr>
              <a:tr h="4133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tient</a:t>
                      </a:r>
                      <a:r>
                        <a:rPr lang="en-US" altLang="ko-KR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09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872616673"/>
                  </a:ext>
                </a:extLst>
              </a:tr>
              <a:tr h="4133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tient</a:t>
                      </a:r>
                      <a:r>
                        <a:rPr lang="en-US" altLang="ko-KR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10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398621221"/>
                  </a:ext>
                </a:extLst>
              </a:tr>
              <a:tr h="4133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atient</a:t>
                      </a:r>
                      <a:r>
                        <a:rPr lang="en-US" altLang="ko-KR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11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382730591"/>
                  </a:ext>
                </a:extLst>
              </a:tr>
            </a:tbl>
          </a:graphicData>
        </a:graphic>
      </p:graphicFrame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2"/>
          <a:srcRect l="15983" r="8373"/>
          <a:stretch/>
        </p:blipFill>
        <p:spPr>
          <a:xfrm>
            <a:off x="2031997" y="232883"/>
            <a:ext cx="6604000" cy="557222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786477" y="5863009"/>
            <a:ext cx="14173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Date of admission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39494" y="5863009"/>
            <a:ext cx="17508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Day of Symptom onset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600035" y="5863009"/>
            <a:ext cx="13276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Day of discharge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그룹 9"/>
          <p:cNvGrpSpPr/>
          <p:nvPr/>
        </p:nvGrpSpPr>
        <p:grpSpPr>
          <a:xfrm>
            <a:off x="8137939" y="3807237"/>
            <a:ext cx="1536172" cy="1172932"/>
            <a:chOff x="10762824" y="4329826"/>
            <a:chExt cx="1536172" cy="1172932"/>
          </a:xfrm>
        </p:grpSpPr>
        <p:sp>
          <p:nvSpPr>
            <p:cNvPr id="11" name="직사각형 10"/>
            <p:cNvSpPr/>
            <p:nvPr/>
          </p:nvSpPr>
          <p:spPr>
            <a:xfrm>
              <a:off x="10762825" y="4384431"/>
              <a:ext cx="140677" cy="1524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직사각형 11"/>
            <p:cNvSpPr/>
            <p:nvPr/>
          </p:nvSpPr>
          <p:spPr>
            <a:xfrm>
              <a:off x="10762824" y="4841631"/>
              <a:ext cx="140677" cy="152400"/>
            </a:xfrm>
            <a:prstGeom prst="rect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직사각형 12"/>
            <p:cNvSpPr/>
            <p:nvPr/>
          </p:nvSpPr>
          <p:spPr>
            <a:xfrm>
              <a:off x="10762824" y="5298831"/>
              <a:ext cx="140677" cy="1524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0948947" y="4329826"/>
              <a:ext cx="11961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Symptom onset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0948946" y="4787026"/>
              <a:ext cx="135005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Recovered patient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0948946" y="5241148"/>
              <a:ext cx="12955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Deceased</a:t>
              </a:r>
              <a:r>
                <a: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patient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720436" y="6262255"/>
            <a:ext cx="934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The hospitalization timeline for SFTS patients.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05639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3</TotalTime>
  <Words>49</Words>
  <Application>Microsoft Office PowerPoint</Application>
  <PresentationFormat>와이드스크린</PresentationFormat>
  <Paragraphs>1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Lee Sang-Yeop</cp:lastModifiedBy>
  <cp:revision>17</cp:revision>
  <dcterms:created xsi:type="dcterms:W3CDTF">2022-05-19T02:21:09Z</dcterms:created>
  <dcterms:modified xsi:type="dcterms:W3CDTF">2022-05-23T05:06:27Z</dcterms:modified>
</cp:coreProperties>
</file>